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9" d="100"/>
          <a:sy n="89" d="100"/>
        </p:scale>
        <p:origin x="-120" y="-304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24CD2-3108-4530-B224-9C79250AFB97}" type="datetimeFigureOut">
              <a:rPr lang="ko-KR" altLang="en-US" smtClean="0"/>
              <a:t>2016-06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55A17-D442-4176-B5A8-2D11CB7F69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93413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24CD2-3108-4530-B224-9C79250AFB97}" type="datetimeFigureOut">
              <a:rPr lang="ko-KR" altLang="en-US" smtClean="0"/>
              <a:t>2016-06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55A17-D442-4176-B5A8-2D11CB7F69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43001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24CD2-3108-4530-B224-9C79250AFB97}" type="datetimeFigureOut">
              <a:rPr lang="ko-KR" altLang="en-US" smtClean="0"/>
              <a:t>2016-06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55A17-D442-4176-B5A8-2D11CB7F69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56935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24CD2-3108-4530-B224-9C79250AFB97}" type="datetimeFigureOut">
              <a:rPr lang="ko-KR" altLang="en-US" smtClean="0"/>
              <a:t>2016-06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55A17-D442-4176-B5A8-2D11CB7F69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01820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24CD2-3108-4530-B224-9C79250AFB97}" type="datetimeFigureOut">
              <a:rPr lang="ko-KR" altLang="en-US" smtClean="0"/>
              <a:t>2016-06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55A17-D442-4176-B5A8-2D11CB7F69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4551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24CD2-3108-4530-B224-9C79250AFB97}" type="datetimeFigureOut">
              <a:rPr lang="ko-KR" altLang="en-US" smtClean="0"/>
              <a:t>2016-06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55A17-D442-4176-B5A8-2D11CB7F69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25889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24CD2-3108-4530-B224-9C79250AFB97}" type="datetimeFigureOut">
              <a:rPr lang="ko-KR" altLang="en-US" smtClean="0"/>
              <a:t>2016-06-0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55A17-D442-4176-B5A8-2D11CB7F69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92191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24CD2-3108-4530-B224-9C79250AFB97}" type="datetimeFigureOut">
              <a:rPr lang="ko-KR" altLang="en-US" smtClean="0"/>
              <a:t>2016-06-0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55A17-D442-4176-B5A8-2D11CB7F69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923954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24CD2-3108-4530-B224-9C79250AFB97}" type="datetimeFigureOut">
              <a:rPr lang="ko-KR" altLang="en-US" smtClean="0"/>
              <a:t>2016-06-0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55A17-D442-4176-B5A8-2D11CB7F69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87012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24CD2-3108-4530-B224-9C79250AFB97}" type="datetimeFigureOut">
              <a:rPr lang="ko-KR" altLang="en-US" smtClean="0"/>
              <a:t>2016-06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55A17-D442-4176-B5A8-2D11CB7F69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77300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C24CD2-3108-4530-B224-9C79250AFB97}" type="datetimeFigureOut">
              <a:rPr lang="ko-KR" altLang="en-US" smtClean="0"/>
              <a:t>2016-06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555A17-D442-4176-B5A8-2D11CB7F69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91044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24CD2-3108-4530-B224-9C79250AFB97}" type="datetimeFigureOut">
              <a:rPr lang="ko-KR" altLang="en-US" smtClean="0"/>
              <a:t>2016-06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555A17-D442-4176-B5A8-2D11CB7F69B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39288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w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218" y="97391"/>
            <a:ext cx="896448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1. Progression-free survival </a:t>
            </a:r>
            <a:r>
              <a:rPr lang="en-US" altLang="ko-KR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f</a:t>
            </a:r>
            <a:r>
              <a:rPr lang="ko-KR" altLang="en-US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atients with unexpected sarcoma </a:t>
            </a:r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tratified by </a:t>
            </a:r>
            <a:r>
              <a:rPr lang="en-US" altLang="ko-KR" sz="16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orcellation</a:t>
            </a:r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rocedure.</a:t>
            </a:r>
            <a:endParaRPr lang="ko-KR" altLang="en-US" sz="16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848" y="908720"/>
            <a:ext cx="7641339" cy="55573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725709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2218" y="132168"/>
            <a:ext cx="896448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2. Progression-free survival </a:t>
            </a:r>
            <a:r>
              <a:rPr lang="en-US" altLang="ko-KR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f</a:t>
            </a:r>
            <a:r>
              <a:rPr lang="ko-KR" altLang="en-US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atients with unexpected sarcoma </a:t>
            </a:r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tratified by </a:t>
            </a:r>
            <a:r>
              <a:rPr lang="en-US" altLang="ko-KR" sz="1600" dirty="0" err="1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orcellation</a:t>
            </a:r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procedure in myomectomy/subtotal hysterectomy </a:t>
            </a:r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group.</a:t>
            </a:r>
            <a:endParaRPr lang="ko-KR" altLang="en-US" sz="16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58" name="그림 5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301" y="908720"/>
            <a:ext cx="7610358" cy="55348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740045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32218" y="78379"/>
            <a:ext cx="896448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3</a:t>
            </a:r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. Progression-free survival </a:t>
            </a:r>
            <a:r>
              <a:rPr lang="en-US" altLang="ko-KR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of</a:t>
            </a:r>
            <a:r>
              <a:rPr lang="ko-KR" altLang="en-US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 </a:t>
            </a:r>
            <a:r>
              <a:rPr lang="en-US" altLang="ko-KR" sz="1600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patients with unexpected sarcoma </a:t>
            </a:r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stratified by type of initial surgery in myomectomy/subtotal hysterectomy </a:t>
            </a:r>
            <a:r>
              <a:rPr lang="en-US" altLang="ko-KR" sz="1600" dirty="0" smtClean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group.</a:t>
            </a:r>
            <a:endParaRPr lang="ko-KR" altLang="en-US" sz="1600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3301" y="908720"/>
            <a:ext cx="7650342" cy="556388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157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52</Words>
  <Application>Microsoft Office PowerPoint</Application>
  <PresentationFormat>화면 슬라이드 쇼(4:3)</PresentationFormat>
  <Paragraphs>3</Paragraphs>
  <Slides>3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4" baseType="lpstr"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admin</cp:lastModifiedBy>
  <cp:revision>2</cp:revision>
  <dcterms:created xsi:type="dcterms:W3CDTF">2016-06-05T05:19:30Z</dcterms:created>
  <dcterms:modified xsi:type="dcterms:W3CDTF">2016-06-05T05:32:35Z</dcterms:modified>
</cp:coreProperties>
</file>